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5940425" cy="828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08">
          <p15:clr>
            <a:srgbClr val="A4A3A4"/>
          </p15:clr>
        </p15:guide>
        <p15:guide id="2" pos="187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56" autoAdjust="0"/>
    <p:restoredTop sz="94660"/>
  </p:normalViewPr>
  <p:slideViewPr>
    <p:cSldViewPr snapToGrid="0">
      <p:cViewPr>
        <p:scale>
          <a:sx n="200" d="100"/>
          <a:sy n="200" d="100"/>
        </p:scale>
        <p:origin x="461" y="-619"/>
      </p:cViewPr>
      <p:guideLst>
        <p:guide orient="horz" pos="2608"/>
        <p:guide pos="187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8D739A-B9A4-4770-8807-06ADB120EC7E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22513" y="1143000"/>
            <a:ext cx="22129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FD7A50-9A82-49A6-BDEE-61CF5F4F73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23352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22513" y="1143000"/>
            <a:ext cx="22129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CFD7A50-9A82-49A6-BDEE-61CF5F4F73D6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93759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45532" y="1355149"/>
            <a:ext cx="5049361" cy="2882806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42553" y="4349127"/>
            <a:ext cx="4455319" cy="1999180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71CC2-5956-4ADC-B7F1-8D9AB81D6D09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0B9FB-2DD3-4F8A-81CB-010A98A3E5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96750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71CC2-5956-4ADC-B7F1-8D9AB81D6D09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0B9FB-2DD3-4F8A-81CB-010A98A3E5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27826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251117" y="440855"/>
            <a:ext cx="1280904" cy="70172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08405" y="440855"/>
            <a:ext cx="3768457" cy="7017256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71CC2-5956-4ADC-B7F1-8D9AB81D6D09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0B9FB-2DD3-4F8A-81CB-010A98A3E5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4056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71CC2-5956-4ADC-B7F1-8D9AB81D6D09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0B9FB-2DD3-4F8A-81CB-010A98A3E5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2393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5311" y="2064352"/>
            <a:ext cx="5123617" cy="3444416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5311" y="5541354"/>
            <a:ext cx="5123617" cy="1811337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71CC2-5956-4ADC-B7F1-8D9AB81D6D09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0B9FB-2DD3-4F8A-81CB-010A98A3E5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29972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08405" y="2204274"/>
            <a:ext cx="2524681" cy="52538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07340" y="2204274"/>
            <a:ext cx="2524681" cy="52538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71CC2-5956-4ADC-B7F1-8D9AB81D6D09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0B9FB-2DD3-4F8A-81CB-010A98A3E5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31979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9178" y="440856"/>
            <a:ext cx="5123617" cy="1600494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9179" y="2029850"/>
            <a:ext cx="2513077" cy="99479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9179" y="3024647"/>
            <a:ext cx="2513077" cy="444879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07340" y="2029850"/>
            <a:ext cx="2525455" cy="99479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07340" y="3024647"/>
            <a:ext cx="2525455" cy="444879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71CC2-5956-4ADC-B7F1-8D9AB81D6D09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0B9FB-2DD3-4F8A-81CB-010A98A3E5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90409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71CC2-5956-4ADC-B7F1-8D9AB81D6D09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0B9FB-2DD3-4F8A-81CB-010A98A3E5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25241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71CC2-5956-4ADC-B7F1-8D9AB81D6D09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0B9FB-2DD3-4F8A-81CB-010A98A3E5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7879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9178" y="552027"/>
            <a:ext cx="1915942" cy="1932094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25455" y="1192226"/>
            <a:ext cx="3007340" cy="5884451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09178" y="2484120"/>
            <a:ext cx="1915942" cy="4602140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71CC2-5956-4ADC-B7F1-8D9AB81D6D09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0B9FB-2DD3-4F8A-81CB-010A98A3E5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99730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9178" y="552027"/>
            <a:ext cx="1915942" cy="1932094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525455" y="1192226"/>
            <a:ext cx="3007340" cy="5884451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09178" y="2484120"/>
            <a:ext cx="1915942" cy="4602140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71CC2-5956-4ADC-B7F1-8D9AB81D6D09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0B9FB-2DD3-4F8A-81CB-010A98A3E5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9871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08404" y="440856"/>
            <a:ext cx="5123617" cy="160049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8404" y="2204274"/>
            <a:ext cx="5123617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08404" y="7674707"/>
            <a:ext cx="1336596" cy="44085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F71CC2-5956-4ADC-B7F1-8D9AB81D6D09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967766" y="7674707"/>
            <a:ext cx="2004894" cy="44085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195425" y="7674707"/>
            <a:ext cx="1336596" cy="44085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B0B9FB-2DD3-4F8A-81CB-010A98A3E5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39809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4" name="直接连接符 43"/>
          <p:cNvCxnSpPr/>
          <p:nvPr/>
        </p:nvCxnSpPr>
        <p:spPr>
          <a:xfrm>
            <a:off x="3269632" y="547907"/>
            <a:ext cx="2376243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连接符 31"/>
          <p:cNvCxnSpPr/>
          <p:nvPr/>
        </p:nvCxnSpPr>
        <p:spPr>
          <a:xfrm>
            <a:off x="441800" y="559417"/>
            <a:ext cx="2376243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本框 217"/>
          <p:cNvSpPr txBox="1"/>
          <p:nvPr/>
        </p:nvSpPr>
        <p:spPr>
          <a:xfrm>
            <a:off x="1240762" y="295171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ase 2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215"/>
          <p:cNvSpPr txBox="1"/>
          <p:nvPr/>
        </p:nvSpPr>
        <p:spPr>
          <a:xfrm rot="16200000">
            <a:off x="-221309" y="2001175"/>
            <a:ext cx="9252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-cadher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215"/>
          <p:cNvSpPr txBox="1"/>
          <p:nvPr/>
        </p:nvSpPr>
        <p:spPr>
          <a:xfrm rot="16200000">
            <a:off x="2648879" y="2035000"/>
            <a:ext cx="8590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AM134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488" y="768275"/>
            <a:ext cx="2376243" cy="1325648"/>
          </a:xfrm>
          <a:prstGeom prst="rect">
            <a:avLst/>
          </a:prstGeom>
        </p:spPr>
      </p:pic>
      <p:sp>
        <p:nvSpPr>
          <p:cNvPr id="33" name="文本框 32"/>
          <p:cNvSpPr txBox="1"/>
          <p:nvPr/>
        </p:nvSpPr>
        <p:spPr>
          <a:xfrm>
            <a:off x="385482" y="562994"/>
            <a:ext cx="12971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djacent non-tumo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1997802" y="562994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217"/>
          <p:cNvSpPr txBox="1"/>
          <p:nvPr/>
        </p:nvSpPr>
        <p:spPr>
          <a:xfrm>
            <a:off x="4192368" y="295171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ase 2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3219882" y="562994"/>
            <a:ext cx="12971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djacent non-tumo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4832201" y="562994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1051" y="768274"/>
            <a:ext cx="2375006" cy="1324958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9974"/>
          <a:stretch/>
        </p:blipFill>
        <p:spPr>
          <a:xfrm>
            <a:off x="449104" y="2084731"/>
            <a:ext cx="1188121" cy="1324958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9974"/>
          <a:stretch/>
        </p:blipFill>
        <p:spPr>
          <a:xfrm>
            <a:off x="1644610" y="2084731"/>
            <a:ext cx="1188121" cy="1324958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9974"/>
          <a:stretch/>
        </p:blipFill>
        <p:spPr>
          <a:xfrm>
            <a:off x="3265235" y="2084731"/>
            <a:ext cx="1188121" cy="1324958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9974"/>
          <a:stretch/>
        </p:blipFill>
        <p:spPr>
          <a:xfrm>
            <a:off x="4457936" y="2084731"/>
            <a:ext cx="1188121" cy="1324958"/>
          </a:xfrm>
          <a:prstGeom prst="rect">
            <a:avLst/>
          </a:prstGeom>
        </p:spPr>
      </p:pic>
      <p:cxnSp>
        <p:nvCxnSpPr>
          <p:cNvPr id="43" name="直接连接符 42"/>
          <p:cNvCxnSpPr/>
          <p:nvPr/>
        </p:nvCxnSpPr>
        <p:spPr>
          <a:xfrm>
            <a:off x="3276654" y="3949433"/>
            <a:ext cx="2376243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连接符 47"/>
          <p:cNvCxnSpPr/>
          <p:nvPr/>
        </p:nvCxnSpPr>
        <p:spPr>
          <a:xfrm>
            <a:off x="448822" y="3960943"/>
            <a:ext cx="2376243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文本框 217"/>
          <p:cNvSpPr txBox="1"/>
          <p:nvPr/>
        </p:nvSpPr>
        <p:spPr>
          <a:xfrm>
            <a:off x="1247784" y="3696697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ase 3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215"/>
          <p:cNvSpPr txBox="1"/>
          <p:nvPr/>
        </p:nvSpPr>
        <p:spPr>
          <a:xfrm rot="16200000">
            <a:off x="-214287" y="5402701"/>
            <a:ext cx="9252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-cadher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215"/>
          <p:cNvSpPr txBox="1"/>
          <p:nvPr/>
        </p:nvSpPr>
        <p:spPr>
          <a:xfrm rot="16200000">
            <a:off x="2655901" y="5436526"/>
            <a:ext cx="8590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AM134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/>
          <p:cNvSpPr txBox="1"/>
          <p:nvPr/>
        </p:nvSpPr>
        <p:spPr>
          <a:xfrm>
            <a:off x="392504" y="3964520"/>
            <a:ext cx="12971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djacent non-tumo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/>
          <p:cNvSpPr txBox="1"/>
          <p:nvPr/>
        </p:nvSpPr>
        <p:spPr>
          <a:xfrm>
            <a:off x="2004823" y="3964520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217"/>
          <p:cNvSpPr txBox="1"/>
          <p:nvPr/>
        </p:nvSpPr>
        <p:spPr>
          <a:xfrm>
            <a:off x="4199390" y="3696697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ase 3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/>
          <p:cNvSpPr txBox="1"/>
          <p:nvPr/>
        </p:nvSpPr>
        <p:spPr>
          <a:xfrm>
            <a:off x="3226904" y="3964520"/>
            <a:ext cx="12971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djacent non-tumo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/>
          <p:cNvSpPr txBox="1"/>
          <p:nvPr/>
        </p:nvSpPr>
        <p:spPr>
          <a:xfrm>
            <a:off x="4839223" y="3964520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图片 19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0073" y="4180543"/>
            <a:ext cx="2375006" cy="1324958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2860" y="4180543"/>
            <a:ext cx="2375006" cy="1324958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9974"/>
          <a:stretch/>
        </p:blipFill>
        <p:spPr>
          <a:xfrm>
            <a:off x="420073" y="5468767"/>
            <a:ext cx="1188121" cy="1324958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9974"/>
          <a:stretch/>
        </p:blipFill>
        <p:spPr>
          <a:xfrm>
            <a:off x="1599961" y="5468767"/>
            <a:ext cx="1188121" cy="1324958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9974"/>
          <a:stretch/>
        </p:blipFill>
        <p:spPr>
          <a:xfrm>
            <a:off x="3212860" y="5468767"/>
            <a:ext cx="1188121" cy="1324958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9974"/>
          <a:stretch/>
        </p:blipFill>
        <p:spPr>
          <a:xfrm>
            <a:off x="4399744" y="5468767"/>
            <a:ext cx="1188121" cy="1324958"/>
          </a:xfrm>
          <a:prstGeom prst="rect">
            <a:avLst/>
          </a:prstGeom>
        </p:spPr>
      </p:pic>
      <p:cxnSp>
        <p:nvCxnSpPr>
          <p:cNvPr id="62" name="直接连接符 61"/>
          <p:cNvCxnSpPr/>
          <p:nvPr/>
        </p:nvCxnSpPr>
        <p:spPr>
          <a:xfrm>
            <a:off x="1380918" y="1988077"/>
            <a:ext cx="21600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接连接符 57"/>
          <p:cNvCxnSpPr/>
          <p:nvPr/>
        </p:nvCxnSpPr>
        <p:spPr>
          <a:xfrm>
            <a:off x="2572082" y="1988077"/>
            <a:ext cx="21600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接连接符 58"/>
          <p:cNvCxnSpPr/>
          <p:nvPr/>
        </p:nvCxnSpPr>
        <p:spPr>
          <a:xfrm>
            <a:off x="1380918" y="3317767"/>
            <a:ext cx="21600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接连接符 70"/>
          <p:cNvCxnSpPr/>
          <p:nvPr/>
        </p:nvCxnSpPr>
        <p:spPr>
          <a:xfrm>
            <a:off x="2572082" y="3317767"/>
            <a:ext cx="21600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接连接符 76"/>
          <p:cNvCxnSpPr/>
          <p:nvPr/>
        </p:nvCxnSpPr>
        <p:spPr>
          <a:xfrm>
            <a:off x="4189944" y="2018557"/>
            <a:ext cx="21600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接连接符 77"/>
          <p:cNvCxnSpPr/>
          <p:nvPr/>
        </p:nvCxnSpPr>
        <p:spPr>
          <a:xfrm>
            <a:off x="5381108" y="2018557"/>
            <a:ext cx="21600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接连接符 78"/>
          <p:cNvCxnSpPr/>
          <p:nvPr/>
        </p:nvCxnSpPr>
        <p:spPr>
          <a:xfrm>
            <a:off x="4189944" y="3348247"/>
            <a:ext cx="21600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接连接符 79"/>
          <p:cNvCxnSpPr/>
          <p:nvPr/>
        </p:nvCxnSpPr>
        <p:spPr>
          <a:xfrm>
            <a:off x="5381108" y="3348247"/>
            <a:ext cx="21600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接连接符 80"/>
          <p:cNvCxnSpPr/>
          <p:nvPr/>
        </p:nvCxnSpPr>
        <p:spPr>
          <a:xfrm>
            <a:off x="4126344" y="5378977"/>
            <a:ext cx="21600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接连接符 81"/>
          <p:cNvCxnSpPr/>
          <p:nvPr/>
        </p:nvCxnSpPr>
        <p:spPr>
          <a:xfrm>
            <a:off x="5317508" y="5378977"/>
            <a:ext cx="21600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接连接符 82"/>
          <p:cNvCxnSpPr/>
          <p:nvPr/>
        </p:nvCxnSpPr>
        <p:spPr>
          <a:xfrm>
            <a:off x="4126344" y="6708667"/>
            <a:ext cx="21600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接连接符 83"/>
          <p:cNvCxnSpPr/>
          <p:nvPr/>
        </p:nvCxnSpPr>
        <p:spPr>
          <a:xfrm>
            <a:off x="5317508" y="6708667"/>
            <a:ext cx="21600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接连接符 84"/>
          <p:cNvCxnSpPr/>
          <p:nvPr/>
        </p:nvCxnSpPr>
        <p:spPr>
          <a:xfrm>
            <a:off x="1305028" y="5378977"/>
            <a:ext cx="21600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接连接符 85"/>
          <p:cNvCxnSpPr/>
          <p:nvPr/>
        </p:nvCxnSpPr>
        <p:spPr>
          <a:xfrm>
            <a:off x="2496192" y="5378977"/>
            <a:ext cx="21600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接连接符 86"/>
          <p:cNvCxnSpPr/>
          <p:nvPr/>
        </p:nvCxnSpPr>
        <p:spPr>
          <a:xfrm>
            <a:off x="1305028" y="6708667"/>
            <a:ext cx="21600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接连接符 87"/>
          <p:cNvCxnSpPr/>
          <p:nvPr/>
        </p:nvCxnSpPr>
        <p:spPr>
          <a:xfrm>
            <a:off x="2496192" y="6708667"/>
            <a:ext cx="21600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208562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8</TotalTime>
  <Words>25</Words>
  <Application>Microsoft Office PowerPoint</Application>
  <PresentationFormat>自定义</PresentationFormat>
  <Paragraphs>17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rzzq@outlook.com</dc:creator>
  <cp:lastModifiedBy>drzzq@outlook.com</cp:lastModifiedBy>
  <cp:revision>16</cp:revision>
  <dcterms:created xsi:type="dcterms:W3CDTF">2018-06-05T16:56:53Z</dcterms:created>
  <dcterms:modified xsi:type="dcterms:W3CDTF">2018-12-08T11:33:01Z</dcterms:modified>
</cp:coreProperties>
</file>